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316" r:id="rId2"/>
    <p:sldId id="317" r:id="rId3"/>
    <p:sldId id="322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49"/>
  </p:normalViewPr>
  <p:slideViewPr>
    <p:cSldViewPr snapToGrid="0" snapToObjects="1">
      <p:cViewPr varScale="1">
        <p:scale>
          <a:sx n="145" d="100"/>
          <a:sy n="145" d="100"/>
        </p:scale>
        <p:origin x="18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49B670-CB17-5743-A445-DB3EA60C3890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C08348-19A2-EA49-853B-76FCB35BCB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04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498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1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419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220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909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971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838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495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48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10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135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798B8-4B91-F749-B8EA-3A7AE927541D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E453B-A1BD-6548-8311-5921ACC41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19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13" Type="http://schemas.openxmlformats.org/officeDocument/2006/relationships/image" Target="../media/image30.emf"/><Relationship Id="rId18" Type="http://schemas.openxmlformats.org/officeDocument/2006/relationships/image" Target="../media/image35.emf"/><Relationship Id="rId3" Type="http://schemas.openxmlformats.org/officeDocument/2006/relationships/image" Target="../media/image20.emf"/><Relationship Id="rId21" Type="http://schemas.openxmlformats.org/officeDocument/2006/relationships/image" Target="../media/image38.emf"/><Relationship Id="rId7" Type="http://schemas.openxmlformats.org/officeDocument/2006/relationships/image" Target="../media/image24.emf"/><Relationship Id="rId12" Type="http://schemas.openxmlformats.org/officeDocument/2006/relationships/image" Target="../media/image29.emf"/><Relationship Id="rId17" Type="http://schemas.openxmlformats.org/officeDocument/2006/relationships/image" Target="../media/image34.emf"/><Relationship Id="rId2" Type="http://schemas.openxmlformats.org/officeDocument/2006/relationships/image" Target="../media/image19.emf"/><Relationship Id="rId16" Type="http://schemas.openxmlformats.org/officeDocument/2006/relationships/image" Target="../media/image33.emf"/><Relationship Id="rId20" Type="http://schemas.openxmlformats.org/officeDocument/2006/relationships/image" Target="../media/image3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11" Type="http://schemas.openxmlformats.org/officeDocument/2006/relationships/image" Target="../media/image28.emf"/><Relationship Id="rId5" Type="http://schemas.openxmlformats.org/officeDocument/2006/relationships/image" Target="../media/image22.emf"/><Relationship Id="rId15" Type="http://schemas.openxmlformats.org/officeDocument/2006/relationships/image" Target="../media/image32.emf"/><Relationship Id="rId23" Type="http://schemas.openxmlformats.org/officeDocument/2006/relationships/image" Target="../media/image40.emf"/><Relationship Id="rId10" Type="http://schemas.openxmlformats.org/officeDocument/2006/relationships/image" Target="../media/image27.emf"/><Relationship Id="rId19" Type="http://schemas.openxmlformats.org/officeDocument/2006/relationships/image" Target="../media/image36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Relationship Id="rId14" Type="http://schemas.openxmlformats.org/officeDocument/2006/relationships/image" Target="../media/image31.emf"/><Relationship Id="rId22" Type="http://schemas.openxmlformats.org/officeDocument/2006/relationships/image" Target="../media/image3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13" Type="http://schemas.openxmlformats.org/officeDocument/2006/relationships/image" Target="../media/image52.emf"/><Relationship Id="rId3" Type="http://schemas.openxmlformats.org/officeDocument/2006/relationships/image" Target="../media/image42.emf"/><Relationship Id="rId7" Type="http://schemas.openxmlformats.org/officeDocument/2006/relationships/image" Target="../media/image46.emf"/><Relationship Id="rId12" Type="http://schemas.openxmlformats.org/officeDocument/2006/relationships/image" Target="../media/image51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emf"/><Relationship Id="rId11" Type="http://schemas.openxmlformats.org/officeDocument/2006/relationships/image" Target="../media/image50.emf"/><Relationship Id="rId5" Type="http://schemas.openxmlformats.org/officeDocument/2006/relationships/image" Target="../media/image44.emf"/><Relationship Id="rId10" Type="http://schemas.openxmlformats.org/officeDocument/2006/relationships/image" Target="../media/image49.emf"/><Relationship Id="rId4" Type="http://schemas.openxmlformats.org/officeDocument/2006/relationships/image" Target="../media/image43.emf"/><Relationship Id="rId9" Type="http://schemas.openxmlformats.org/officeDocument/2006/relationships/image" Target="../media/image4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66A39CD-0D93-DC4C-887D-7E052E36BB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2196" y="354913"/>
            <a:ext cx="1745303" cy="13332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C2665DA-C08D-9A4B-8D52-1D346D5653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6015" y="357923"/>
            <a:ext cx="1740404" cy="13294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5914078-7D2A-7345-BCA5-7572D0BDCB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3649" y="362081"/>
            <a:ext cx="1732966" cy="13237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C07C9C6-0601-504D-BA21-E97D0636BD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6217" y="4362881"/>
            <a:ext cx="1816470" cy="138757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5CE6A85-8C52-8C42-BAEA-BFA0AD326E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20951" y="4355757"/>
            <a:ext cx="1737698" cy="132740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ED48E4E-BA91-434A-BA7C-24B3601A2F8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38486" y="4370146"/>
            <a:ext cx="1729246" cy="132095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ED2A43E-92ED-644E-B8FF-4EC4F3D522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3649" y="1697510"/>
            <a:ext cx="1742703" cy="133122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5D3B18E-DC88-2445-AB78-BD5FDC9B270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23012" y="3040135"/>
            <a:ext cx="1741105" cy="133001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74856AC-BCFE-574F-92FD-58497CACFAC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84334" y="3040178"/>
            <a:ext cx="1737698" cy="132740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80991B0-18AF-6740-B9F8-7260F3D90BE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00049" y="1697441"/>
            <a:ext cx="1742533" cy="133110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308A59F-C08D-324E-B0D4-1AFF01E8950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36054" y="1693102"/>
            <a:ext cx="1739960" cy="132913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9ED13A7-646F-244F-81A7-9FA5F2CD0E6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6156" y="3052317"/>
            <a:ext cx="1717177" cy="131173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9842233-74A3-B049-9853-9FCF3E1A3B5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471390" y="1689035"/>
            <a:ext cx="1753539" cy="133950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7A56A73-192A-F445-8E5B-0A900EAE1DF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120370" y="3049446"/>
            <a:ext cx="1722212" cy="131557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68A5186-D285-DD47-9684-BF310FA4A60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068892" y="362081"/>
            <a:ext cx="1729246" cy="1320951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5270D0E-6D30-CB40-9117-2E2866CF422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76014" y="5690896"/>
            <a:ext cx="1699957" cy="129857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F3BB9D07-6DDE-3445-A466-A95A1815198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57219" y="5696219"/>
            <a:ext cx="1739189" cy="132854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42E3109C-DFBC-4844-8C2F-3C8DFD4C7DF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76014" y="6989474"/>
            <a:ext cx="1828800" cy="1397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F2EF5D4-F46D-2B44-96ED-0FCC59C2ACA0}"/>
              </a:ext>
            </a:extLst>
          </p:cNvPr>
          <p:cNvSpPr/>
          <p:nvPr/>
        </p:nvSpPr>
        <p:spPr>
          <a:xfrm>
            <a:off x="183770" y="8648097"/>
            <a:ext cx="6564489" cy="4321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000" b="1" dirty="0">
                <a:latin typeface="TimesNewRomanPS"/>
                <a:ea typeface="Times New Roman" panose="02020603050405020304" pitchFamily="18" charset="0"/>
              </a:rPr>
              <a:t>Supplementary Figure 3. Piperacetazine IC50 values across various cell lines. 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Cells were treated for 48 hours at various piperacetazine concentrations, and cell viability was measured via </a:t>
            </a:r>
            <a:r>
              <a:rPr lang="en-US" sz="1000" dirty="0" err="1">
                <a:latin typeface="TimesNewRomanPSMT" panose="02020603050405020304" pitchFamily="18" charset="0"/>
                <a:ea typeface="Times New Roman" panose="02020603050405020304" pitchFamily="18" charset="0"/>
              </a:rPr>
              <a:t>CellTiter</a:t>
            </a:r>
            <a:r>
              <a:rPr lang="en-US" sz="1000" dirty="0">
                <a:latin typeface="TimesNewRomanPSMT" panose="02020603050405020304" pitchFamily="18" charset="0"/>
                <a:ea typeface="Times New Roman" panose="02020603050405020304" pitchFamily="18" charset="0"/>
              </a:rPr>
              <a:t>-Blue assay. 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9899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ABC2A94-C5B2-6F4B-A896-50901AEF05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827" y="1659778"/>
            <a:ext cx="1626523" cy="12537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A6D6FE4-6A69-B742-B253-E30AF634B3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7553" y="362219"/>
            <a:ext cx="1654932" cy="12641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45EC06-699E-004E-97B8-5F6D3D9A14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8655" y="3035980"/>
            <a:ext cx="1693150" cy="12933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73A2291-1AED-1743-90C8-4832D569BA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92644" y="5845744"/>
            <a:ext cx="1607240" cy="122775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1F7B1A3-2DB2-B042-9C1D-4ACDF30450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66973" y="3028314"/>
            <a:ext cx="1658581" cy="127848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A7BC914-49C0-5144-88D2-F48100A2D1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1508" y="337469"/>
            <a:ext cx="1663323" cy="129369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8225B38-A53B-BC45-86DF-08903091023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25410" y="3030650"/>
            <a:ext cx="1732289" cy="132327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76CEC78-9014-414F-96D4-0E2E8101CA8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65899" y="4431293"/>
            <a:ext cx="1650055" cy="126045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1EC7F92-5816-0D41-9BDF-06B0BAEC73A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46434" y="4434839"/>
            <a:ext cx="1655741" cy="126480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567EB45-15E5-5C4B-8713-5B53F56655D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02175" y="5846376"/>
            <a:ext cx="1676243" cy="128046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48D0B96-4554-BC44-AACE-0B336D06DA0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27353" y="350810"/>
            <a:ext cx="1639914" cy="125271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8902C97-3CAF-3048-87BF-A26E9BE3A01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48654" y="1701021"/>
            <a:ext cx="1643990" cy="126724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28B0A0A-F201-014F-A509-9BAC08AD727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24324" y="1707626"/>
            <a:ext cx="1653390" cy="126300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AA9968AD-C3B5-B548-A702-5F76F67D499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63110" y="3014360"/>
            <a:ext cx="1596860" cy="1219822"/>
          </a:xfrm>
          <a:prstGeom prst="rect">
            <a:avLst/>
          </a:prstGeom>
        </p:spPr>
      </p:pic>
      <p:sp>
        <p:nvSpPr>
          <p:cNvPr id="25" name="Google Shape;301;p11">
            <a:extLst>
              <a:ext uri="{FF2B5EF4-FFF2-40B4-BE49-F238E27FC236}">
                <a16:creationId xmlns:a16="http://schemas.microsoft.com/office/drawing/2014/main" id="{5F616A12-F1AC-D24F-AC7C-6A3E78A136A4}"/>
              </a:ext>
            </a:extLst>
          </p:cNvPr>
          <p:cNvSpPr txBox="1"/>
          <p:nvPr/>
        </p:nvSpPr>
        <p:spPr>
          <a:xfrm>
            <a:off x="4361674" y="8642956"/>
            <a:ext cx="2528510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45700" rIns="91426" bIns="45700" anchor="t" anchorCtr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(continued). </a:t>
            </a:r>
            <a:endParaRPr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83180418-BDEE-D04E-B73A-EAABC1AC70F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84980" y="362219"/>
            <a:ext cx="1688463" cy="123432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FC0A8B01-256F-C840-BEAD-24F29071CD2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03791" y="4420622"/>
            <a:ext cx="1772869" cy="126286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E5A11BE-76AF-D6B2-6668-206A6395E795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16480" y="5845744"/>
            <a:ext cx="1690119" cy="12907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97C301F-8F40-3E7E-FE49-390987B6702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57894" y="4371988"/>
            <a:ext cx="1732290" cy="134401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F2532A0-D56B-EB14-9B08-D736F67EEC0E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32686" y="1704836"/>
            <a:ext cx="1650055" cy="126579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19254CA-EEC1-F49A-AB55-12F02681785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964779" y="5822168"/>
            <a:ext cx="1732289" cy="132887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2037679-B0EA-5298-C01A-7A9E62037F76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570267" y="7152268"/>
            <a:ext cx="1740057" cy="132887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E49DB5C-CC93-C4ED-364D-BF72B356F5B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123467" y="7152023"/>
            <a:ext cx="1740058" cy="1328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66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DC2C942A-AF3D-9A46-85FC-C1CEEA9B04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786" y="3014468"/>
            <a:ext cx="1651382" cy="126147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18EB397-C9BB-5B4B-A0E0-B14C6912C7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7168" y="4349767"/>
            <a:ext cx="1665834" cy="126127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3DDFB65-AC25-4841-BF60-586DEECEBD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2880" y="264067"/>
            <a:ext cx="1674301" cy="1278981"/>
          </a:xfrm>
          <a:prstGeom prst="rect">
            <a:avLst/>
          </a:prstGeom>
        </p:spPr>
      </p:pic>
      <p:sp>
        <p:nvSpPr>
          <p:cNvPr id="25" name="Google Shape;301;p11">
            <a:extLst>
              <a:ext uri="{FF2B5EF4-FFF2-40B4-BE49-F238E27FC236}">
                <a16:creationId xmlns:a16="http://schemas.microsoft.com/office/drawing/2014/main" id="{5F616A12-F1AC-D24F-AC7C-6A3E78A136A4}"/>
              </a:ext>
            </a:extLst>
          </p:cNvPr>
          <p:cNvSpPr txBox="1"/>
          <p:nvPr/>
        </p:nvSpPr>
        <p:spPr>
          <a:xfrm>
            <a:off x="4356074" y="5838210"/>
            <a:ext cx="6586882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6" tIns="45700" rIns="91426" bIns="45700" anchor="t" anchorCtr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(continued). </a:t>
            </a:r>
            <a:endParaRPr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50CD9E02-A452-DC4E-BF79-0FA4E2C56F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6869" y="4361827"/>
            <a:ext cx="1660312" cy="126829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B517F4B-B1A6-3EBC-26E7-319CFA2AF57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5786" y="1640710"/>
            <a:ext cx="1658265" cy="127209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0DA6051-1E47-D481-0C64-E0DF9F3C4BB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17371" y="239564"/>
            <a:ext cx="1665287" cy="127209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2FFFB4C-E5F4-FDF1-DA0B-3EB3F654B25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99680" y="1628193"/>
            <a:ext cx="1658265" cy="1272094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4668612-2940-6D6D-B1AE-C6A1F61EDB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26942" y="208174"/>
            <a:ext cx="1665702" cy="127209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9DE5031D-1F96-0EF8-1C9A-3B04488AA5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26942" y="1637647"/>
            <a:ext cx="1658264" cy="126775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27F3A9BB-78C2-9872-E3BB-CAD4AEB422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34596" y="182240"/>
            <a:ext cx="1665288" cy="1272094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E1892771-02C6-E0A2-12D9-755906FE04E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34596" y="1635474"/>
            <a:ext cx="1658267" cy="127209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1E5EB75-4532-4067-0DB4-FA44019B8F9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999680" y="3014468"/>
            <a:ext cx="1651382" cy="1266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8543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4</Words>
  <Application>Microsoft Macintosh PowerPoint</Application>
  <PresentationFormat>Letter Paper (8.5x11 in)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imesNewRomanPS</vt:lpstr>
      <vt:lpstr>TimesNewRomanPSM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6</cp:revision>
  <dcterms:created xsi:type="dcterms:W3CDTF">2023-07-14T20:06:09Z</dcterms:created>
  <dcterms:modified xsi:type="dcterms:W3CDTF">2023-08-23T14:59:17Z</dcterms:modified>
</cp:coreProperties>
</file>